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893"/>
    <a:srgbClr val="942093"/>
    <a:srgbClr val="9437FF"/>
    <a:srgbClr val="FF9300"/>
    <a:srgbClr val="929292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04"/>
    <p:restoredTop sz="96310"/>
  </p:normalViewPr>
  <p:slideViewPr>
    <p:cSldViewPr snapToGrid="0">
      <p:cViewPr>
        <p:scale>
          <a:sx n="88" d="100"/>
          <a:sy n="88" d="100"/>
        </p:scale>
        <p:origin x="5168" y="6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6A4D8E-4468-8940-8495-075939C632A2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EE1239-6483-EE4F-A3E6-E515071B15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7593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026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356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175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528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62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317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911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717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747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312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499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078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D4B2DFC-7AA9-9360-BB75-CCE6A6D837D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9129"/>
          <a:stretch/>
        </p:blipFill>
        <p:spPr>
          <a:xfrm>
            <a:off x="228601" y="412751"/>
            <a:ext cx="2133881" cy="133985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9C12F06-4485-3AD2-05AF-D5B465F4D4F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296" t="-1" b="11030"/>
          <a:stretch/>
        </p:blipFill>
        <p:spPr>
          <a:xfrm>
            <a:off x="2407538" y="412751"/>
            <a:ext cx="1978197" cy="131183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7ADEA85-4FBC-5914-546C-216F7213A50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296" b="11029"/>
          <a:stretch/>
        </p:blipFill>
        <p:spPr>
          <a:xfrm>
            <a:off x="4541419" y="412750"/>
            <a:ext cx="1978197" cy="131183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8537068-6B08-6BDA-AC72-005CB5DF7528}"/>
              </a:ext>
            </a:extLst>
          </p:cNvPr>
          <p:cNvSpPr txBox="1"/>
          <p:nvPr/>
        </p:nvSpPr>
        <p:spPr>
          <a:xfrm>
            <a:off x="348784" y="289638"/>
            <a:ext cx="20810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aseline PBMCs: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edian IFN-</a:t>
            </a:r>
            <a:r>
              <a:rPr lang="en-US" sz="10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A1BE835-DD68-6FD0-7917-4EEF7F1A77B2}"/>
              </a:ext>
            </a:extLst>
          </p:cNvPr>
          <p:cNvSpPr txBox="1"/>
          <p:nvPr/>
        </p:nvSpPr>
        <p:spPr>
          <a:xfrm>
            <a:off x="2418119" y="275723"/>
            <a:ext cx="19960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eek 6 PBMCs: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edian IFN-</a:t>
            </a:r>
            <a:r>
              <a:rPr lang="en-US" sz="10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E9B8D9F-3192-1E07-5AB6-2871F64416B4}"/>
              </a:ext>
            </a:extLst>
          </p:cNvPr>
          <p:cNvSpPr txBox="1"/>
          <p:nvPr/>
        </p:nvSpPr>
        <p:spPr>
          <a:xfrm>
            <a:off x="4421455" y="275723"/>
            <a:ext cx="23214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Weeks 10-39 PBMCs: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edian IFN-</a:t>
            </a:r>
            <a:r>
              <a:rPr lang="en-US" sz="10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Symbol" pitchFamily="2" charset="2"/>
              <a:cs typeface="Arial" panose="020B0604020202020204" pitchFamily="34" charset="0"/>
            </a:endParaRP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AEFC84B-ED9C-919C-0677-3C8C24CAC6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7437124"/>
              </p:ext>
            </p:extLst>
          </p:nvPr>
        </p:nvGraphicFramePr>
        <p:xfrm>
          <a:off x="435989" y="1937207"/>
          <a:ext cx="1884936" cy="317398"/>
        </p:xfrm>
        <a:graphic>
          <a:graphicData uri="http://schemas.openxmlformats.org/drawingml/2006/table">
            <a:tbl>
              <a:tblPr/>
              <a:tblGrid>
                <a:gridCol w="280781">
                  <a:extLst>
                    <a:ext uri="{9D8B030D-6E8A-4147-A177-3AD203B41FA5}">
                      <a16:colId xmlns:a16="http://schemas.microsoft.com/office/drawing/2014/main" val="135179121"/>
                    </a:ext>
                  </a:extLst>
                </a:gridCol>
                <a:gridCol w="240910">
                  <a:extLst>
                    <a:ext uri="{9D8B030D-6E8A-4147-A177-3AD203B41FA5}">
                      <a16:colId xmlns:a16="http://schemas.microsoft.com/office/drawing/2014/main" val="945705335"/>
                    </a:ext>
                  </a:extLst>
                </a:gridCol>
                <a:gridCol w="295315">
                  <a:extLst>
                    <a:ext uri="{9D8B030D-6E8A-4147-A177-3AD203B41FA5}">
                      <a16:colId xmlns:a16="http://schemas.microsoft.com/office/drawing/2014/main" val="730130826"/>
                    </a:ext>
                  </a:extLst>
                </a:gridCol>
                <a:gridCol w="237787">
                  <a:extLst>
                    <a:ext uri="{9D8B030D-6E8A-4147-A177-3AD203B41FA5}">
                      <a16:colId xmlns:a16="http://schemas.microsoft.com/office/drawing/2014/main" val="1933581299"/>
                    </a:ext>
                  </a:extLst>
                </a:gridCol>
                <a:gridCol w="260798">
                  <a:extLst>
                    <a:ext uri="{9D8B030D-6E8A-4147-A177-3AD203B41FA5}">
                      <a16:colId xmlns:a16="http://schemas.microsoft.com/office/drawing/2014/main" val="3440882432"/>
                    </a:ext>
                  </a:extLst>
                </a:gridCol>
                <a:gridCol w="269671">
                  <a:extLst>
                    <a:ext uri="{9D8B030D-6E8A-4147-A177-3AD203B41FA5}">
                      <a16:colId xmlns:a16="http://schemas.microsoft.com/office/drawing/2014/main" val="2247752671"/>
                    </a:ext>
                  </a:extLst>
                </a:gridCol>
                <a:gridCol w="299674">
                  <a:extLst>
                    <a:ext uri="{9D8B030D-6E8A-4147-A177-3AD203B41FA5}">
                      <a16:colId xmlns:a16="http://schemas.microsoft.com/office/drawing/2014/main" val="2006098803"/>
                    </a:ext>
                  </a:extLst>
                </a:gridCol>
              </a:tblGrid>
              <a:tr h="12949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8072398"/>
                  </a:ext>
                </a:extLst>
              </a:tr>
              <a:tr h="1009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6099445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D068D459-1886-5FB1-55A5-42976BF423F0}"/>
              </a:ext>
            </a:extLst>
          </p:cNvPr>
          <p:cNvSpPr txBox="1"/>
          <p:nvPr/>
        </p:nvSpPr>
        <p:spPr>
          <a:xfrm rot="16200000">
            <a:off x="-9511" y="1947345"/>
            <a:ext cx="707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# at risk: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15DB1612-9541-AB36-7FF0-5B0A723E5DB9}"/>
              </a:ext>
            </a:extLst>
          </p:cNvPr>
          <p:cNvCxnSpPr>
            <a:cxnSpLocks/>
          </p:cNvCxnSpPr>
          <p:nvPr/>
        </p:nvCxnSpPr>
        <p:spPr>
          <a:xfrm>
            <a:off x="454062" y="1975841"/>
            <a:ext cx="0" cy="27876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4" name="Table 13">
            <a:extLst>
              <a:ext uri="{FF2B5EF4-FFF2-40B4-BE49-F238E27FC236}">
                <a16:creationId xmlns:a16="http://schemas.microsoft.com/office/drawing/2014/main" id="{940FFE16-329A-09C3-C53E-F6BDFA1884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0541508"/>
              </p:ext>
            </p:extLst>
          </p:nvPr>
        </p:nvGraphicFramePr>
        <p:xfrm>
          <a:off x="2485756" y="1939757"/>
          <a:ext cx="1884936" cy="317398"/>
        </p:xfrm>
        <a:graphic>
          <a:graphicData uri="http://schemas.openxmlformats.org/drawingml/2006/table">
            <a:tbl>
              <a:tblPr/>
              <a:tblGrid>
                <a:gridCol w="280781">
                  <a:extLst>
                    <a:ext uri="{9D8B030D-6E8A-4147-A177-3AD203B41FA5}">
                      <a16:colId xmlns:a16="http://schemas.microsoft.com/office/drawing/2014/main" val="135179121"/>
                    </a:ext>
                  </a:extLst>
                </a:gridCol>
                <a:gridCol w="240910">
                  <a:extLst>
                    <a:ext uri="{9D8B030D-6E8A-4147-A177-3AD203B41FA5}">
                      <a16:colId xmlns:a16="http://schemas.microsoft.com/office/drawing/2014/main" val="945705335"/>
                    </a:ext>
                  </a:extLst>
                </a:gridCol>
                <a:gridCol w="295315">
                  <a:extLst>
                    <a:ext uri="{9D8B030D-6E8A-4147-A177-3AD203B41FA5}">
                      <a16:colId xmlns:a16="http://schemas.microsoft.com/office/drawing/2014/main" val="730130826"/>
                    </a:ext>
                  </a:extLst>
                </a:gridCol>
                <a:gridCol w="237787">
                  <a:extLst>
                    <a:ext uri="{9D8B030D-6E8A-4147-A177-3AD203B41FA5}">
                      <a16:colId xmlns:a16="http://schemas.microsoft.com/office/drawing/2014/main" val="1933581299"/>
                    </a:ext>
                  </a:extLst>
                </a:gridCol>
                <a:gridCol w="260798">
                  <a:extLst>
                    <a:ext uri="{9D8B030D-6E8A-4147-A177-3AD203B41FA5}">
                      <a16:colId xmlns:a16="http://schemas.microsoft.com/office/drawing/2014/main" val="3440882432"/>
                    </a:ext>
                  </a:extLst>
                </a:gridCol>
                <a:gridCol w="269671">
                  <a:extLst>
                    <a:ext uri="{9D8B030D-6E8A-4147-A177-3AD203B41FA5}">
                      <a16:colId xmlns:a16="http://schemas.microsoft.com/office/drawing/2014/main" val="2247752671"/>
                    </a:ext>
                  </a:extLst>
                </a:gridCol>
                <a:gridCol w="299674">
                  <a:extLst>
                    <a:ext uri="{9D8B030D-6E8A-4147-A177-3AD203B41FA5}">
                      <a16:colId xmlns:a16="http://schemas.microsoft.com/office/drawing/2014/main" val="2006098803"/>
                    </a:ext>
                  </a:extLst>
                </a:gridCol>
              </a:tblGrid>
              <a:tr h="12949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 6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 0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8072398"/>
                  </a:ext>
                </a:extLst>
              </a:tr>
              <a:tr h="592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  16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  6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6099445"/>
                  </a:ext>
                </a:extLst>
              </a:tr>
            </a:tbl>
          </a:graphicData>
        </a:graphic>
      </p:graphicFrame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A24F4D1C-D91D-6280-3605-4212C190E7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2693020"/>
              </p:ext>
            </p:extLst>
          </p:nvPr>
        </p:nvGraphicFramePr>
        <p:xfrm>
          <a:off x="4623722" y="1932322"/>
          <a:ext cx="1884936" cy="317398"/>
        </p:xfrm>
        <a:graphic>
          <a:graphicData uri="http://schemas.openxmlformats.org/drawingml/2006/table">
            <a:tbl>
              <a:tblPr/>
              <a:tblGrid>
                <a:gridCol w="280781">
                  <a:extLst>
                    <a:ext uri="{9D8B030D-6E8A-4147-A177-3AD203B41FA5}">
                      <a16:colId xmlns:a16="http://schemas.microsoft.com/office/drawing/2014/main" val="135179121"/>
                    </a:ext>
                  </a:extLst>
                </a:gridCol>
                <a:gridCol w="240910">
                  <a:extLst>
                    <a:ext uri="{9D8B030D-6E8A-4147-A177-3AD203B41FA5}">
                      <a16:colId xmlns:a16="http://schemas.microsoft.com/office/drawing/2014/main" val="945705335"/>
                    </a:ext>
                  </a:extLst>
                </a:gridCol>
                <a:gridCol w="295315">
                  <a:extLst>
                    <a:ext uri="{9D8B030D-6E8A-4147-A177-3AD203B41FA5}">
                      <a16:colId xmlns:a16="http://schemas.microsoft.com/office/drawing/2014/main" val="730130826"/>
                    </a:ext>
                  </a:extLst>
                </a:gridCol>
                <a:gridCol w="237787">
                  <a:extLst>
                    <a:ext uri="{9D8B030D-6E8A-4147-A177-3AD203B41FA5}">
                      <a16:colId xmlns:a16="http://schemas.microsoft.com/office/drawing/2014/main" val="1933581299"/>
                    </a:ext>
                  </a:extLst>
                </a:gridCol>
                <a:gridCol w="260798">
                  <a:extLst>
                    <a:ext uri="{9D8B030D-6E8A-4147-A177-3AD203B41FA5}">
                      <a16:colId xmlns:a16="http://schemas.microsoft.com/office/drawing/2014/main" val="3440882432"/>
                    </a:ext>
                  </a:extLst>
                </a:gridCol>
                <a:gridCol w="269671">
                  <a:extLst>
                    <a:ext uri="{9D8B030D-6E8A-4147-A177-3AD203B41FA5}">
                      <a16:colId xmlns:a16="http://schemas.microsoft.com/office/drawing/2014/main" val="2247752671"/>
                    </a:ext>
                  </a:extLst>
                </a:gridCol>
                <a:gridCol w="299674">
                  <a:extLst>
                    <a:ext uri="{9D8B030D-6E8A-4147-A177-3AD203B41FA5}">
                      <a16:colId xmlns:a16="http://schemas.microsoft.com/office/drawing/2014/main" val="2006098803"/>
                    </a:ext>
                  </a:extLst>
                </a:gridCol>
              </a:tblGrid>
              <a:tr h="12949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 7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 1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8072398"/>
                  </a:ext>
                </a:extLst>
              </a:tr>
              <a:tr h="592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  12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  9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299" marR="6299" marT="62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6099445"/>
                  </a:ext>
                </a:extLst>
              </a:tr>
            </a:tbl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378BCE15-E0C6-843C-645C-737AE4A461BB}"/>
              </a:ext>
            </a:extLst>
          </p:cNvPr>
          <p:cNvSpPr txBox="1"/>
          <p:nvPr/>
        </p:nvSpPr>
        <p:spPr>
          <a:xfrm>
            <a:off x="2536207" y="1160930"/>
            <a:ext cx="7825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009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: 0.37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: 0.17-0.7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461E5E0-1D80-6898-0C9B-6482AAF4ADF1}"/>
              </a:ext>
            </a:extLst>
          </p:cNvPr>
          <p:cNvSpPr txBox="1"/>
          <p:nvPr/>
        </p:nvSpPr>
        <p:spPr>
          <a:xfrm>
            <a:off x="1432517" y="1160929"/>
            <a:ext cx="7825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25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: 0.44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: 0.11-1.78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A798902-F263-B803-4C0B-3E16262E071A}"/>
              </a:ext>
            </a:extLst>
          </p:cNvPr>
          <p:cNvSpPr txBox="1"/>
          <p:nvPr/>
        </p:nvSpPr>
        <p:spPr>
          <a:xfrm>
            <a:off x="4670088" y="1160928"/>
            <a:ext cx="7825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007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: 0.30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: 0.13-0.7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689B372-8B36-9985-1BCC-C6ED82BB3993}"/>
              </a:ext>
            </a:extLst>
          </p:cNvPr>
          <p:cNvSpPr txBox="1"/>
          <p:nvPr/>
        </p:nvSpPr>
        <p:spPr>
          <a:xfrm>
            <a:off x="1104561" y="1725432"/>
            <a:ext cx="707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Day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E79BF13-563B-6121-4159-73E029763058}"/>
              </a:ext>
            </a:extLst>
          </p:cNvPr>
          <p:cNvSpPr txBox="1"/>
          <p:nvPr/>
        </p:nvSpPr>
        <p:spPr>
          <a:xfrm>
            <a:off x="3176633" y="1724954"/>
            <a:ext cx="707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Day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ED719A1-0038-E118-EF65-76D8D3BABB09}"/>
              </a:ext>
            </a:extLst>
          </p:cNvPr>
          <p:cNvSpPr txBox="1"/>
          <p:nvPr/>
        </p:nvSpPr>
        <p:spPr>
          <a:xfrm>
            <a:off x="5329629" y="1738860"/>
            <a:ext cx="707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Day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00BFCF4-E170-24B7-672D-191321E3226C}"/>
              </a:ext>
            </a:extLst>
          </p:cNvPr>
          <p:cNvSpPr txBox="1"/>
          <p:nvPr/>
        </p:nvSpPr>
        <p:spPr>
          <a:xfrm>
            <a:off x="15317" y="2447279"/>
            <a:ext cx="29206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/>
              <a:t>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8367597-E0D0-FAEC-BFB3-79C79E4193B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985"/>
          <a:stretch/>
        </p:blipFill>
        <p:spPr>
          <a:xfrm>
            <a:off x="705920" y="2507108"/>
            <a:ext cx="2495760" cy="194981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E0711F5-E45F-2B54-C4F7-46EE9465949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087"/>
          <a:stretch/>
        </p:blipFill>
        <p:spPr>
          <a:xfrm>
            <a:off x="3440019" y="2486715"/>
            <a:ext cx="2531909" cy="1943661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8C2F5ECA-15E0-1646-FAA2-923F50574986}"/>
              </a:ext>
            </a:extLst>
          </p:cNvPr>
          <p:cNvSpPr txBox="1"/>
          <p:nvPr/>
        </p:nvSpPr>
        <p:spPr>
          <a:xfrm>
            <a:off x="2637091" y="2479806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hit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412267F-C50E-485F-DDD5-189523E594A8}"/>
              </a:ext>
            </a:extLst>
          </p:cNvPr>
          <p:cNvSpPr txBox="1"/>
          <p:nvPr/>
        </p:nvSpPr>
        <p:spPr>
          <a:xfrm>
            <a:off x="2637091" y="2647129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ack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5390C50-51F0-D796-D07D-C6C6D1819032}"/>
              </a:ext>
            </a:extLst>
          </p:cNvPr>
          <p:cNvSpPr txBox="1"/>
          <p:nvPr/>
        </p:nvSpPr>
        <p:spPr>
          <a:xfrm>
            <a:off x="5452675" y="2478923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hit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1C0D15D-171B-38A7-E19F-C7AEB3B8D091}"/>
              </a:ext>
            </a:extLst>
          </p:cNvPr>
          <p:cNvSpPr txBox="1"/>
          <p:nvPr/>
        </p:nvSpPr>
        <p:spPr>
          <a:xfrm>
            <a:off x="5452675" y="2646246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ack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5B0A371-6956-BE3D-52D3-45DA0481CAF3}"/>
              </a:ext>
            </a:extLst>
          </p:cNvPr>
          <p:cNvSpPr txBox="1"/>
          <p:nvPr/>
        </p:nvSpPr>
        <p:spPr>
          <a:xfrm rot="16200000">
            <a:off x="80730" y="3243885"/>
            <a:ext cx="10374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old mock IFN-</a:t>
            </a:r>
            <a:r>
              <a:rPr lang="en-US" sz="900" dirty="0">
                <a:latin typeface="Symbol" pitchFamily="2" charset="2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566B2AA-9410-44A8-10BE-63C29AD0B79F}"/>
              </a:ext>
            </a:extLst>
          </p:cNvPr>
          <p:cNvSpPr txBox="1"/>
          <p:nvPr/>
        </p:nvSpPr>
        <p:spPr>
          <a:xfrm rot="16200000">
            <a:off x="2844436" y="3214443"/>
            <a:ext cx="10374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old mock IFN-</a:t>
            </a:r>
            <a:r>
              <a:rPr lang="en-US" sz="900" dirty="0">
                <a:latin typeface="Symbol" pitchFamily="2" charset="2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9B9103A-05CF-AD36-479C-4610F9931EA6}"/>
              </a:ext>
            </a:extLst>
          </p:cNvPr>
          <p:cNvSpPr txBox="1"/>
          <p:nvPr/>
        </p:nvSpPr>
        <p:spPr>
          <a:xfrm>
            <a:off x="12803" y="4404694"/>
            <a:ext cx="30649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/>
              <a:t>C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BF5E328D-5763-C2A8-29B4-A4F76EF90678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b="9798"/>
          <a:stretch/>
        </p:blipFill>
        <p:spPr>
          <a:xfrm>
            <a:off x="2374055" y="4420551"/>
            <a:ext cx="2011680" cy="1479927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0F4216B7-5B01-04E2-4953-AB5C19A8F3CF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b="9798"/>
          <a:stretch/>
        </p:blipFill>
        <p:spPr>
          <a:xfrm>
            <a:off x="4359985" y="4419059"/>
            <a:ext cx="2011680" cy="1479928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037C1F64-817F-361A-4B5E-80989DE0D865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b="9798"/>
          <a:stretch/>
        </p:blipFill>
        <p:spPr>
          <a:xfrm>
            <a:off x="484786" y="5985929"/>
            <a:ext cx="2011680" cy="1479927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25DDE488-E894-7436-98FF-2BE0D5D3FEBB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b="11742"/>
          <a:stretch/>
        </p:blipFill>
        <p:spPr>
          <a:xfrm>
            <a:off x="2357327" y="5986895"/>
            <a:ext cx="2011680" cy="1448014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DDC619FB-69DB-F2F6-623C-68AD73111802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b="9855"/>
          <a:stretch/>
        </p:blipFill>
        <p:spPr>
          <a:xfrm>
            <a:off x="484786" y="4426566"/>
            <a:ext cx="2011680" cy="1472947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11BB0A05-C65A-A777-8605-4006BD5932DD}"/>
              </a:ext>
            </a:extLst>
          </p:cNvPr>
          <p:cNvSpPr txBox="1"/>
          <p:nvPr/>
        </p:nvSpPr>
        <p:spPr>
          <a:xfrm>
            <a:off x="2708790" y="5228836"/>
            <a:ext cx="7248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25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: 0.74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: 0.45-1.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9948BA2-39CB-FA21-94DA-74B879E2E9BE}"/>
              </a:ext>
            </a:extLst>
          </p:cNvPr>
          <p:cNvSpPr txBox="1"/>
          <p:nvPr/>
        </p:nvSpPr>
        <p:spPr>
          <a:xfrm>
            <a:off x="4692670" y="5235277"/>
            <a:ext cx="7248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07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: 0.63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: 0.38-1.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C357B60-ECF6-E995-B5DA-1CE759A899D8}"/>
              </a:ext>
            </a:extLst>
          </p:cNvPr>
          <p:cNvSpPr txBox="1"/>
          <p:nvPr/>
        </p:nvSpPr>
        <p:spPr>
          <a:xfrm>
            <a:off x="821432" y="6818053"/>
            <a:ext cx="7248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24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: 1.4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: 0.82-2.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FD8AE9E-EC09-9C6A-E8B3-B2BD855CD7B7}"/>
              </a:ext>
            </a:extLst>
          </p:cNvPr>
          <p:cNvSpPr txBox="1"/>
          <p:nvPr/>
        </p:nvSpPr>
        <p:spPr>
          <a:xfrm>
            <a:off x="2703347" y="6805795"/>
            <a:ext cx="7248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12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: 1.5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: 0.90-2.5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3C4CB2C-F108-EF84-AEB1-EBCC16798C6A}"/>
              </a:ext>
            </a:extLst>
          </p:cNvPr>
          <p:cNvSpPr txBox="1"/>
          <p:nvPr/>
        </p:nvSpPr>
        <p:spPr>
          <a:xfrm>
            <a:off x="821432" y="5250224"/>
            <a:ext cx="7248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17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R: 1.52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: 0.83-2.8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EFB52B4-14F1-7F44-1DCB-AF74AA3D8C99}"/>
              </a:ext>
            </a:extLst>
          </p:cNvPr>
          <p:cNvSpPr txBox="1"/>
          <p:nvPr/>
        </p:nvSpPr>
        <p:spPr>
          <a:xfrm>
            <a:off x="11660" y="202603"/>
            <a:ext cx="29206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/>
              <a:t>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86E8C9A-4CC4-2A39-AA47-EE974D42FF03}"/>
              </a:ext>
            </a:extLst>
          </p:cNvPr>
          <p:cNvSpPr txBox="1"/>
          <p:nvPr/>
        </p:nvSpPr>
        <p:spPr>
          <a:xfrm>
            <a:off x="101448" y="7666429"/>
            <a:ext cx="6629399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 (related to Fig 2). 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Survival of PRIME cohort patients separated by time point of PBMC collection. P-values are from log-rank test and Hazard ratios -/+ 95% CI are from Mantel-Haenszel tests.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Scatter plots comparing fold mock IFN-</a:t>
            </a:r>
            <a:r>
              <a:rPr lang="en-US" sz="1200" dirty="0">
                <a:solidFill>
                  <a:srgbClr val="212121"/>
                </a:solidFill>
                <a:effectLst/>
                <a:latin typeface="Symbol" pitchFamily="2" charset="2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duction after TLR1/2 stimulation and Age or log(PSA) values; Black individuals are coded in red.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Kaplan-Meier separations of post-sip-T survival by ECOG score (0 vs &gt;0) or by median CD54 upregulation, total nucleated cell content (TNC), prostate specific antigen (PSA), or Age (in years). All data sets are n=106, except for PSA in (C) which was n=104 due to lacking PSA values in 2 patients. 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2104A48-CE4C-DBE0-E813-F3AB39E5A89D}"/>
              </a:ext>
            </a:extLst>
          </p:cNvPr>
          <p:cNvSpPr txBox="1"/>
          <p:nvPr/>
        </p:nvSpPr>
        <p:spPr>
          <a:xfrm>
            <a:off x="0" y="-21905"/>
            <a:ext cx="643364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 S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A5A0481-F41F-D512-66A1-50B90A280041}"/>
              </a:ext>
            </a:extLst>
          </p:cNvPr>
          <p:cNvSpPr txBox="1"/>
          <p:nvPr/>
        </p:nvSpPr>
        <p:spPr>
          <a:xfrm>
            <a:off x="1360064" y="5832544"/>
            <a:ext cx="707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Days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5B5F96B-5FC4-AE45-1680-5C541115179A}"/>
              </a:ext>
            </a:extLst>
          </p:cNvPr>
          <p:cNvSpPr txBox="1"/>
          <p:nvPr/>
        </p:nvSpPr>
        <p:spPr>
          <a:xfrm>
            <a:off x="3301243" y="5832544"/>
            <a:ext cx="707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Day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D4126D2-A123-98FD-3818-419367D0C8DF}"/>
              </a:ext>
            </a:extLst>
          </p:cNvPr>
          <p:cNvSpPr txBox="1"/>
          <p:nvPr/>
        </p:nvSpPr>
        <p:spPr>
          <a:xfrm>
            <a:off x="5312052" y="5827788"/>
            <a:ext cx="707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Day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F3FBAEF-DCF1-B315-C709-176D0981A2F5}"/>
              </a:ext>
            </a:extLst>
          </p:cNvPr>
          <p:cNvSpPr txBox="1"/>
          <p:nvPr/>
        </p:nvSpPr>
        <p:spPr>
          <a:xfrm>
            <a:off x="1360064" y="7400373"/>
            <a:ext cx="707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Day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BA00CC9-F56F-C474-8644-3511E3A2FE7D}"/>
              </a:ext>
            </a:extLst>
          </p:cNvPr>
          <p:cNvSpPr txBox="1"/>
          <p:nvPr/>
        </p:nvSpPr>
        <p:spPr>
          <a:xfrm>
            <a:off x="3301243" y="7404275"/>
            <a:ext cx="707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Days</a:t>
            </a:r>
          </a:p>
        </p:txBody>
      </p:sp>
    </p:spTree>
    <p:extLst>
      <p:ext uri="{BB962C8B-B14F-4D97-AF65-F5344CB8AC3E}">
        <p14:creationId xmlns:p14="http://schemas.microsoft.com/office/powerpoint/2010/main" val="1088795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364</TotalTime>
  <Words>307</Words>
  <Application>Microsoft Macintosh PowerPoint</Application>
  <PresentationFormat>Letter Paper (8.5x11 in)</PresentationFormat>
  <Paragraphs>8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Brown</dc:creator>
  <cp:lastModifiedBy>Michael Brown</cp:lastModifiedBy>
  <cp:revision>36</cp:revision>
  <dcterms:created xsi:type="dcterms:W3CDTF">2024-05-14T01:47:53Z</dcterms:created>
  <dcterms:modified xsi:type="dcterms:W3CDTF">2024-09-16T20:07:43Z</dcterms:modified>
</cp:coreProperties>
</file>